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7099300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CED1D7-9D00-448C-B9AA-D750DDF6E01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639B79-0E84-49A4-9839-75AEC55012E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00A75C-D61E-4CBE-B059-DFB98C50E6B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B5AB1F-3624-49F8-A202-E60FBB47DFB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9321BB-281D-462A-871C-50B4098F5C7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30118C-5864-48E4-90C6-BE895081851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BBBC3F-CAC6-4A4F-9B56-ED8B997551D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3AE6EE-C39B-4729-9C3F-867D7A692CA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12520"/>
            <a:ext cx="58291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425B7E-5F39-4681-B180-F009C37B797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403169-B949-4D2A-BC0B-961A1EFAB2F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CEBA9C-5499-4C93-9C4D-881FE31D15F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D19D1D-1E03-4646-860B-68504D9284F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2884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31120"/>
            <a:ext cx="217152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95B6C07-75B5-492B-8469-164A282C798E}" type="slidenum"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>
            <a:grayscl/>
          </a:blip>
          <a:stretch/>
        </p:blipFill>
        <p:spPr>
          <a:xfrm>
            <a:off x="406440" y="1987560"/>
            <a:ext cx="1923840" cy="1173240"/>
          </a:xfrm>
          <a:prstGeom prst="rect">
            <a:avLst/>
          </a:prstGeom>
          <a:ln w="0">
            <a:noFill/>
          </a:ln>
        </p:spPr>
      </p:pic>
      <p:pic>
        <p:nvPicPr>
          <p:cNvPr id="42" name="" descr=""/>
          <p:cNvPicPr/>
          <p:nvPr/>
        </p:nvPicPr>
        <p:blipFill>
          <a:blip r:embed="rId2">
            <a:grayscl/>
          </a:blip>
          <a:stretch/>
        </p:blipFill>
        <p:spPr>
          <a:xfrm>
            <a:off x="404640" y="4087800"/>
            <a:ext cx="1917720" cy="1287360"/>
          </a:xfrm>
          <a:prstGeom prst="rect">
            <a:avLst/>
          </a:prstGeom>
          <a:ln w="0">
            <a:noFill/>
          </a:ln>
        </p:spPr>
      </p:pic>
      <p:pic>
        <p:nvPicPr>
          <p:cNvPr id="43" name="" descr=""/>
          <p:cNvPicPr/>
          <p:nvPr/>
        </p:nvPicPr>
        <p:blipFill>
          <a:blip r:embed="rId3">
            <a:grayscl/>
          </a:blip>
          <a:stretch/>
        </p:blipFill>
        <p:spPr>
          <a:xfrm>
            <a:off x="404640" y="3017880"/>
            <a:ext cx="1873440" cy="1211400"/>
          </a:xfrm>
          <a:prstGeom prst="rect">
            <a:avLst/>
          </a:prstGeom>
          <a:ln w="0">
            <a:noFill/>
          </a:ln>
        </p:spPr>
      </p:pic>
      <p:sp>
        <p:nvSpPr>
          <p:cNvPr id="44" name=""/>
          <p:cNvSpPr/>
          <p:nvPr/>
        </p:nvSpPr>
        <p:spPr>
          <a:xfrm>
            <a:off x="827640" y="4294080"/>
            <a:ext cx="356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M1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45" name=""/>
          <p:cNvGrpSpPr/>
          <p:nvPr/>
        </p:nvGrpSpPr>
        <p:grpSpPr>
          <a:xfrm>
            <a:off x="241200" y="4692240"/>
            <a:ext cx="1222560" cy="1201680"/>
            <a:chOff x="241200" y="4692240"/>
            <a:chExt cx="1222560" cy="1201680"/>
          </a:xfrm>
        </p:grpSpPr>
        <p:grpSp>
          <p:nvGrpSpPr>
            <p:cNvPr id="46" name=""/>
            <p:cNvGrpSpPr/>
            <p:nvPr/>
          </p:nvGrpSpPr>
          <p:grpSpPr>
            <a:xfrm>
              <a:off x="450720" y="5200560"/>
              <a:ext cx="380520" cy="495360"/>
              <a:chOff x="450720" y="5200560"/>
              <a:chExt cx="380520" cy="495360"/>
            </a:xfrm>
          </p:grpSpPr>
          <p:sp>
            <p:nvSpPr>
              <p:cNvPr id="47" name=""/>
              <p:cNvSpPr/>
              <p:nvPr/>
            </p:nvSpPr>
            <p:spPr>
              <a:xfrm>
                <a:off x="450720" y="5200560"/>
                <a:ext cx="0" cy="4824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headEnd len="med" type="stealth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8" name=""/>
              <p:cNvSpPr/>
              <p:nvPr/>
            </p:nvSpPr>
            <p:spPr>
              <a:xfrm flipH="1">
                <a:off x="462960" y="5695920"/>
                <a:ext cx="3682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headEnd len="med" type="stealth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sp>
          <p:nvSpPr>
            <p:cNvPr id="49" name=""/>
            <p:cNvSpPr/>
            <p:nvPr/>
          </p:nvSpPr>
          <p:spPr>
            <a:xfrm>
              <a:off x="385560" y="5678280"/>
              <a:ext cx="10782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TMRE fluorescence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0" name=""/>
            <p:cNvSpPr/>
            <p:nvPr/>
          </p:nvSpPr>
          <p:spPr>
            <a:xfrm rot="16200000">
              <a:off x="-191880" y="5125680"/>
              <a:ext cx="1082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Cell number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pic>
        <p:nvPicPr>
          <p:cNvPr id="51" name="" descr=""/>
          <p:cNvPicPr/>
          <p:nvPr/>
        </p:nvPicPr>
        <p:blipFill>
          <a:blip r:embed="rId4">
            <a:grayscl/>
          </a:blip>
          <a:stretch/>
        </p:blipFill>
        <p:spPr>
          <a:xfrm>
            <a:off x="368280" y="901800"/>
            <a:ext cx="1887480" cy="1162080"/>
          </a:xfrm>
          <a:prstGeom prst="rect">
            <a:avLst/>
          </a:prstGeom>
          <a:ln w="0">
            <a:noFill/>
          </a:ln>
        </p:spPr>
      </p:pic>
      <p:sp>
        <p:nvSpPr>
          <p:cNvPr id="52" name=""/>
          <p:cNvSpPr/>
          <p:nvPr/>
        </p:nvSpPr>
        <p:spPr>
          <a:xfrm>
            <a:off x="783360" y="1049400"/>
            <a:ext cx="356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M1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3" name=""/>
          <p:cNvSpPr/>
          <p:nvPr/>
        </p:nvSpPr>
        <p:spPr>
          <a:xfrm>
            <a:off x="789480" y="2122560"/>
            <a:ext cx="356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M1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4" name=""/>
          <p:cNvSpPr/>
          <p:nvPr/>
        </p:nvSpPr>
        <p:spPr>
          <a:xfrm>
            <a:off x="799200" y="3182760"/>
            <a:ext cx="356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M1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5" name=""/>
          <p:cNvSpPr/>
          <p:nvPr/>
        </p:nvSpPr>
        <p:spPr>
          <a:xfrm>
            <a:off x="3779640" y="442800"/>
            <a:ext cx="2640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Gubser 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</a:rPr>
              <a:t>et al.,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 Supplementary data 2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6" name=""/>
          <p:cNvSpPr/>
          <p:nvPr/>
        </p:nvSpPr>
        <p:spPr>
          <a:xfrm rot="16200000">
            <a:off x="90720" y="1301760"/>
            <a:ext cx="483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mock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7" name=""/>
          <p:cNvSpPr/>
          <p:nvPr/>
        </p:nvSpPr>
        <p:spPr>
          <a:xfrm rot="16200000">
            <a:off x="-93960" y="2224800"/>
            <a:ext cx="930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siRNA1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8" name=""/>
          <p:cNvSpPr/>
          <p:nvPr/>
        </p:nvSpPr>
        <p:spPr>
          <a:xfrm rot="16200000">
            <a:off x="-108360" y="3231360"/>
            <a:ext cx="930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siRNA2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9" name=""/>
          <p:cNvSpPr/>
          <p:nvPr/>
        </p:nvSpPr>
        <p:spPr>
          <a:xfrm rot="16200000">
            <a:off x="-124200" y="4363200"/>
            <a:ext cx="930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siRNA3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6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caro</cp:lastModifiedBy>
  <dcterms:modified xsi:type="dcterms:W3CDTF">2006-11-27T14:36:09Z</dcterms:modified>
  <cp:revision>75</cp:revision>
  <dc:subject/>
  <dc:title>PowerPoint Presentation</dc:title>
</cp:coreProperties>
</file>